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772"/>
    <p:restoredTop sz="96197"/>
  </p:normalViewPr>
  <p:slideViewPr>
    <p:cSldViewPr snapToGrid="0" snapToObjects="1">
      <p:cViewPr varScale="1">
        <p:scale>
          <a:sx n="77" d="100"/>
          <a:sy n="77" d="100"/>
        </p:scale>
        <p:origin x="192" y="1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26CE9-9676-C276-54FE-A55286D356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9AC8BD-C5AE-9B6A-0819-8D49E138F5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ECF3FA-FD74-1B95-E8DA-B34D853F5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74E35A-A07A-795C-8A66-9DDB49D13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99A519-7165-7115-2BFF-455F764EC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499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C26720-12C7-8045-F1CB-8D94DD0510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37DF0E-CCBE-6E02-83D9-B6B722A5DC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A7F24A-AB9C-9C66-426B-A85831FE1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87052A-6EFB-AA8E-3A5B-4DD31D43A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F3F152-C823-B38E-E163-757848093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315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7940D0-9EFF-2775-D8F5-FF3C05CB07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9A6D68-FAB2-4397-5BBD-A84722D2C2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0F9B19-BC08-5515-8A0A-227B4D772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9CA7F1-F169-7862-DD33-CACDBB30B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F93C48-8CAA-7BE4-E6CA-C75F0C3C7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161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69C52-B7D3-3712-E1E4-300E5E1C17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8D7D06-595E-906E-B8AC-487E00A7BD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802DDF-3F79-C477-E156-096F16773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B9ED75-A6C3-0EC7-D5D5-60AAE1DE5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EDBA9E-FD0A-22ED-6CF1-FD13BB9BE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509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136BE-87D5-DF60-2FBB-36B766DF93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A04355-12F8-38F1-9440-FD024B5D84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BEC39F-B7EE-7D1E-E238-182C50F70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AF3BA1-5593-AFBA-B536-905E06A08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946716-062E-189C-0BE6-50570E8B5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968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22AAF8-1F1F-7EF5-3659-AF781B2D7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1820BD-B116-CD8C-2675-76B3ECFDAE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5D0015-3B90-4B58-1F49-41239E6319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BD9E16-39C1-A8EB-3E75-1A6B8C5CE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5F2040-36EC-743E-F7E4-06AFC7786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00F2D8-13DF-BB39-C793-C6D40A64F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649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F2022-E348-C842-BA24-FA430E074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DF6B72-1BFB-D8C8-2A7C-D5AC19069F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A8DA94-32EB-66CF-D919-2D1A86AC6B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C2AD21-1E15-65C6-5C07-250314B83A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546EE1-EF06-D14F-7BE6-46F1866494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FE1ACC-0178-682B-B154-B9CDD93AF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D074BA1-3769-6403-F42C-43CC337E0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DA50050-76D9-7141-5EF4-C629BCD4B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438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8EA2C9-943D-2C20-2B4C-FF1DD1B781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692C6A-40E1-6CE7-A24F-5B050DBD4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AD2850-2EED-B7C4-75CE-83FF46568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B04199-3F26-B130-F4F4-8B04D17B2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83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DB65A1-0E92-7993-31F8-A5582CC88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E52FA8-31D7-08E2-14AD-8E8409AFA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37C1D5-626E-4B5C-6196-CEC2CC5C0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839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9BB6B4-8595-BFDC-8EAF-2D435DAFCF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D3AB46-8FAD-B438-F04B-12526C0A17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4280E2-9B6F-0955-137C-924EC5ED04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8B234E-1A81-33AC-8235-EFC9CC49C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4D6FBE-26E1-0F3E-E25A-2B9AB6425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62AA5B-F811-0601-C85A-99D79939F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836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71E1AE-22BF-90E6-FD5D-B39524DDD4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786F5E0-3986-C9CD-DFB5-E57F309B7A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E02EC3-C646-B35F-2110-246CFFD5AD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0EFEF2-FC14-9B1F-93C8-8157DA7F7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29DC66-609B-24C5-F164-1DA8333D2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02E337-244C-712F-C68C-E9D243991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303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4810B8-6AFA-7B3C-0F7E-A401ABA9F5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1F4871-F19D-87ED-6B4A-A9CAE70891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B9D5C9-AD2C-A529-A682-3B7774E0B1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63286-F63B-BC4C-A27E-C06FEB1A5518}" type="datetimeFigureOut">
              <a:rPr lang="en-US" smtClean="0"/>
              <a:t>5/9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3EA238-7196-7EE8-61F2-AE549F0E73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86D633-B7B7-1C11-8F76-0F4F4AABB6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E78C0-7567-4E47-BA34-D244FEB188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851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A picture containing shirt&#10;&#10;Description automatically generated">
            <a:extLst>
              <a:ext uri="{FF2B5EF4-FFF2-40B4-BE49-F238E27FC236}">
                <a16:creationId xmlns:a16="http://schemas.microsoft.com/office/drawing/2014/main" id="{65405A68-4FEF-D560-73E0-CEC022FDAE0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2" t="21904" r="4732" b="16825"/>
          <a:stretch/>
        </p:blipFill>
        <p:spPr bwMode="auto">
          <a:xfrm>
            <a:off x="576943" y="696686"/>
            <a:ext cx="11038114" cy="42018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FAF47FC-6E6C-E50D-7DA3-728A6C76A443}"/>
              </a:ext>
            </a:extLst>
          </p:cNvPr>
          <p:cNvSpPr txBox="1"/>
          <p:nvPr/>
        </p:nvSpPr>
        <p:spPr>
          <a:xfrm>
            <a:off x="576943" y="5220392"/>
            <a:ext cx="109112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bependymal tumor along the floor of the fourth ventricle in a human DIPG specimen. </a:t>
            </a:r>
            <a:r>
              <a:rPr lang="en-US" dirty="0"/>
              <a:t>(A-B) </a:t>
            </a:r>
            <a:r>
              <a:rPr lang="en-US" dirty="0" err="1"/>
              <a:t>Photomicroraph</a:t>
            </a:r>
            <a:r>
              <a:rPr lang="en-US" dirty="0"/>
              <a:t> showing tumor cells in the subependymal of the fourth ventricle. Tumor cells are indicated with arrows. A-B 20x magnification, scale bars = 50 µm. </a:t>
            </a:r>
          </a:p>
        </p:txBody>
      </p:sp>
    </p:spTree>
    <p:extLst>
      <p:ext uri="{BB962C8B-B14F-4D97-AF65-F5344CB8AC3E}">
        <p14:creationId xmlns:p14="http://schemas.microsoft.com/office/powerpoint/2010/main" val="1412126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</TotalTime>
  <Words>4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Shelei</dc:creator>
  <cp:lastModifiedBy>Pan, Shelei</cp:lastModifiedBy>
  <cp:revision>1</cp:revision>
  <dcterms:created xsi:type="dcterms:W3CDTF">2022-05-09T19:01:24Z</dcterms:created>
  <dcterms:modified xsi:type="dcterms:W3CDTF">2022-05-10T01:13:25Z</dcterms:modified>
</cp:coreProperties>
</file>